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360ADFF-8C13-46E3-85FA-F2D56CE90B30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3A3E802-869F-4681-9DB9-FDDA61C1AE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E44E75F-9E7E-44BD-9F8E-8E30C7C452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D091926-76FC-4263-81C6-83B517876B7B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ED95582-1D33-4716-AAB6-5943F063F2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8F43D0C-FDFC-4407-966F-2482F7A400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86410F2-902D-43F8-BF7D-DE79F3A52D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638212B-D7BE-426B-8E9B-45DBB8CDDB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A67C28D-D52D-415A-8479-222E6D7F0F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969A168-D44E-4D5F-9AB5-CEBD9DCFE7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42A7833-1EE7-4B9E-AE1C-404810650A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83D52A5-57DC-439F-A638-6E1AFB207F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3" name="Text Box 4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fld id="{09CC6551-4544-4E9E-8BBD-8681616F0A7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1093680" y="2286000"/>
            <a:ext cx="2079720" cy="942840"/>
          </a:xfrm>
          <a:prstGeom prst="rect">
            <a:avLst/>
          </a:prstGeom>
          <a:noFill/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Questionnaire + Density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N = 2868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533 cases 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   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2" name="Rectangle 2"/>
          <p:cNvSpPr/>
          <p:nvPr/>
        </p:nvSpPr>
        <p:spPr>
          <a:xfrm>
            <a:off x="1069920" y="3811680"/>
            <a:ext cx="2144880" cy="760320"/>
          </a:xfrm>
          <a:prstGeom prst="rect">
            <a:avLst/>
          </a:prstGeom>
          <a:noFill/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Analysis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N = 2717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474 cases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3" name="Rectangle 3"/>
          <p:cNvSpPr/>
          <p:nvPr/>
        </p:nvSpPr>
        <p:spPr>
          <a:xfrm>
            <a:off x="3549600" y="2378160"/>
            <a:ext cx="3765600" cy="2662200"/>
          </a:xfrm>
          <a:prstGeom prst="rect">
            <a:avLst/>
          </a:prstGeom>
          <a:noFill/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Excluded 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N = 151 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59 cases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1 no BI-RADS density available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6 mammogram &gt;5y prior to diagnosis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18 aged &lt; 40y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24 aged 80y+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9 unknown side (unable to determine contralateral breast density)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	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1 missing demographic data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92 controls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9 aged &lt;40y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74 aged 80y+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9 missing demographic data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</p:txBody>
      </p:sp>
      <p:cxnSp>
        <p:nvCxnSpPr>
          <p:cNvPr id="44" name="AutoShape 4"/>
          <p:cNvCxnSpPr>
            <a:stCxn id="41" idx="2"/>
            <a:endCxn id="42" idx="0"/>
          </p:cNvCxnSpPr>
          <p:nvPr/>
        </p:nvCxnSpPr>
        <p:spPr>
          <a:xfrm>
            <a:off x="2133360" y="3228840"/>
            <a:ext cx="9360" cy="583200"/>
          </a:xfrm>
          <a:prstGeom prst="straightConnector1">
            <a:avLst/>
          </a:prstGeom>
          <a:ln cap="sq" w="324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5" name="AutoShape 5"/>
          <p:cNvCxnSpPr/>
          <p:nvPr/>
        </p:nvCxnSpPr>
        <p:spPr>
          <a:xfrm>
            <a:off x="2133360" y="3462480"/>
            <a:ext cx="1392840" cy="2160"/>
          </a:xfrm>
          <a:prstGeom prst="straightConnector1">
            <a:avLst/>
          </a:prstGeom>
          <a:ln cap="sq" w="324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6" name="Rectangle 6"/>
          <p:cNvSpPr/>
          <p:nvPr/>
        </p:nvSpPr>
        <p:spPr>
          <a:xfrm>
            <a:off x="0" y="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7" name="Rectangle 7"/>
          <p:cNvSpPr/>
          <p:nvPr/>
        </p:nvSpPr>
        <p:spPr>
          <a:xfrm>
            <a:off x="4481640" y="228600"/>
            <a:ext cx="180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br>
              <a:rPr sz="1200"/>
            </a:br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8" name="Rectangle 8"/>
          <p:cNvSpPr/>
          <p:nvPr/>
        </p:nvSpPr>
        <p:spPr>
          <a:xfrm>
            <a:off x="1066680" y="762120"/>
            <a:ext cx="2148120" cy="942840"/>
          </a:xfrm>
          <a:prstGeom prst="rect">
            <a:avLst/>
          </a:prstGeom>
          <a:noFill/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Case-control study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Digital mammogram, 2003-13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N = 2997 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658 cases 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9" name="Rectangle 9"/>
          <p:cNvSpPr/>
          <p:nvPr/>
        </p:nvSpPr>
        <p:spPr>
          <a:xfrm>
            <a:off x="3559320" y="1440000"/>
            <a:ext cx="3755880" cy="863640"/>
          </a:xfrm>
          <a:prstGeom prst="rect">
            <a:avLst/>
          </a:prstGeom>
          <a:noFill/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MS Mincho"/>
              </a:rPr>
              <a:t>Excluded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N = 125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125 cases 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72 deceased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53 lost to follow up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MS Mincho"/>
              </a:rPr>
              <a:t>      </a:t>
            </a:r>
            <a:endParaRPr b="0" lang="en-US" sz="1000" spc="-1" strike="noStrike">
              <a:solidFill>
                <a:srgbClr val="ffffff"/>
              </a:solidFill>
              <a:latin typeface="Calibri"/>
            </a:endParaRPr>
          </a:p>
        </p:txBody>
      </p:sp>
      <p:cxnSp>
        <p:nvCxnSpPr>
          <p:cNvPr id="50" name="AutoShape 10"/>
          <p:cNvCxnSpPr>
            <a:stCxn id="48" idx="2"/>
            <a:endCxn id="41" idx="0"/>
          </p:cNvCxnSpPr>
          <p:nvPr/>
        </p:nvCxnSpPr>
        <p:spPr>
          <a:xfrm flipH="1">
            <a:off x="2133360" y="1704960"/>
            <a:ext cx="7560" cy="581400"/>
          </a:xfrm>
          <a:prstGeom prst="straightConnector1">
            <a:avLst/>
          </a:prstGeom>
          <a:ln cap="sq" w="324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1" name="AutoShape 11"/>
          <p:cNvCxnSpPr/>
          <p:nvPr/>
        </p:nvCxnSpPr>
        <p:spPr>
          <a:xfrm flipV="1">
            <a:off x="2157480" y="1983600"/>
            <a:ext cx="1402560" cy="1080"/>
          </a:xfrm>
          <a:prstGeom prst="straightConnector1">
            <a:avLst/>
          </a:prstGeom>
          <a:ln cap="sq" w="3240">
            <a:solidFill>
              <a:srgbClr val="000000"/>
            </a:solidFill>
            <a:miter/>
            <a:tailEnd len="med" type="triangle" w="med"/>
          </a:ln>
        </p:spPr>
      </p:cxn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9-27T17:37:10Z</dcterms:created>
  <dc:creator>QMCR Postmaster</dc:creator>
  <dc:description/>
  <dc:language>en-US</dc:language>
  <cp:lastModifiedBy>""</cp:lastModifiedBy>
  <dcterms:modified xsi:type="dcterms:W3CDTF">2019-03-04T17:56:36Z</dcterms:modified>
  <cp:revision>11</cp:revision>
  <dc:subject/>
  <dc:title>PowerPoint Presentation</dc:title>
</cp:coreProperties>
</file>